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5939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8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46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8871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4993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2559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754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686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199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906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368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152C9-A3BA-4B6D-AABD-5467561F681B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05024-A4B3-44EF-A79B-B1F74C4E234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3076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004513"/>
              </p:ext>
            </p:extLst>
          </p:nvPr>
        </p:nvGraphicFramePr>
        <p:xfrm>
          <a:off x="195943" y="150701"/>
          <a:ext cx="11808824" cy="7033870"/>
        </p:xfrm>
        <a:graphic>
          <a:graphicData uri="http://schemas.openxmlformats.org/drawingml/2006/table">
            <a:tbl>
              <a:tblPr/>
              <a:tblGrid>
                <a:gridCol w="1968137">
                  <a:extLst>
                    <a:ext uri="{9D8B030D-6E8A-4147-A177-3AD203B41FA5}">
                      <a16:colId xmlns:a16="http://schemas.microsoft.com/office/drawing/2014/main" val="4072707516"/>
                    </a:ext>
                  </a:extLst>
                </a:gridCol>
                <a:gridCol w="1328294">
                  <a:extLst>
                    <a:ext uri="{9D8B030D-6E8A-4147-A177-3AD203B41FA5}">
                      <a16:colId xmlns:a16="http://schemas.microsoft.com/office/drawing/2014/main" val="1260937932"/>
                    </a:ext>
                  </a:extLst>
                </a:gridCol>
                <a:gridCol w="2221789">
                  <a:extLst>
                    <a:ext uri="{9D8B030D-6E8A-4147-A177-3AD203B41FA5}">
                      <a16:colId xmlns:a16="http://schemas.microsoft.com/office/drawing/2014/main" val="1202699228"/>
                    </a:ext>
                  </a:extLst>
                </a:gridCol>
                <a:gridCol w="2168253">
                  <a:extLst>
                    <a:ext uri="{9D8B030D-6E8A-4147-A177-3AD203B41FA5}">
                      <a16:colId xmlns:a16="http://schemas.microsoft.com/office/drawing/2014/main" val="1435017195"/>
                    </a:ext>
                  </a:extLst>
                </a:gridCol>
                <a:gridCol w="2154214">
                  <a:extLst>
                    <a:ext uri="{9D8B030D-6E8A-4147-A177-3AD203B41FA5}">
                      <a16:colId xmlns:a16="http://schemas.microsoft.com/office/drawing/2014/main" val="3510031588"/>
                    </a:ext>
                  </a:extLst>
                </a:gridCol>
                <a:gridCol w="1968137">
                  <a:extLst>
                    <a:ext uri="{9D8B030D-6E8A-4147-A177-3AD203B41FA5}">
                      <a16:colId xmlns:a16="http://schemas.microsoft.com/office/drawing/2014/main" val="1825876600"/>
                    </a:ext>
                  </a:extLst>
                </a:gridCol>
              </a:tblGrid>
              <a:tr h="181183">
                <a:tc gridSpan="6">
                  <a:txBody>
                    <a:bodyPr/>
                    <a:lstStyle/>
                    <a:p>
                      <a:pPr marL="0" marR="0" lvl="0" indent="0" algn="just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</a:t>
                      </a:r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.</a:t>
                      </a:r>
                      <a:r>
                        <a:rPr lang="en-GB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GB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een amendment effect on soil pore water (SPW) pH, electrical conductivity (EC), redox potential (Eh) and metal(loid) concentrations determined at the beginning (T0) and at the end (</a:t>
                      </a:r>
                      <a:r>
                        <a:rPr lang="en-GB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) </a:t>
                      </a:r>
                      <a:r>
                        <a:rPr lang="en-GB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 the experiment; on CaCl2-extractable metal(loid) concentrations, plant pigments (nitrogen balance index (NBI), chlorophyll, flavonoid and anthocyanin contents), and plant metal(loid) concentrations. Levels of significance: </a:t>
                      </a:r>
                      <a:r>
                        <a:rPr lang="fr-FR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 p &lt; 0.05, ** p &lt; 0.01, *** p &lt; 0. 001 and ns = non-</a:t>
                      </a:r>
                      <a:r>
                        <a:rPr lang="fr-FR" sz="1200" b="0" i="0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ificant</a:t>
                      </a:r>
                      <a:r>
                        <a:rPr lang="fr-FR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</a:t>
                      </a:r>
                      <a:r>
                        <a:rPr lang="fr-FR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918545"/>
                  </a:ext>
                </a:extLst>
              </a:tr>
              <a:tr h="18118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+B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+O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G+Ac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777567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pH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2494614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7217458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EC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3227708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73649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Eh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5260607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5087210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[As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5748323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1019953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[Fe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5813150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1899674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W [Pb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6637352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8015137"/>
                  </a:ext>
                </a:extLst>
              </a:tr>
              <a:tr h="20706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l</a:t>
                      </a:r>
                      <a:r>
                        <a:rPr lang="en-GB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[As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3472643"/>
                  </a:ext>
                </a:extLst>
              </a:tr>
              <a:tr h="20706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l</a:t>
                      </a:r>
                      <a:r>
                        <a:rPr lang="en-GB" sz="12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[Fe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3457985"/>
                  </a:ext>
                </a:extLst>
              </a:tr>
              <a:tr h="20706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l</a:t>
                      </a:r>
                      <a:r>
                        <a:rPr lang="en-GB" sz="12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[Pb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9725724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BI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8323923"/>
                  </a:ext>
                </a:extLst>
              </a:tr>
              <a:tr h="172555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ophyll content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6664404"/>
                  </a:ext>
                </a:extLst>
              </a:tr>
              <a:tr h="172555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vonoid content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6828932"/>
                  </a:ext>
                </a:extLst>
              </a:tr>
              <a:tr h="172555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hocyanin content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5821271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m length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5125269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af DW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4438275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m DW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84344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DW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2825479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af [As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4540994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m [As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7735651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[As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1595313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af [Fe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1828312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m [Fe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7837501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[Fe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5639361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af [Pb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6207447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m [Pb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059852"/>
                  </a:ext>
                </a:extLst>
              </a:tr>
              <a:tr h="18118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[Pb]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1158358"/>
                  </a:ext>
                </a:extLst>
              </a:tr>
              <a:tr h="17255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6086" marR="6086" marT="608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87921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02183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3</TotalTime>
  <Words>357</Words>
  <Application>Microsoft Office PowerPoint</Application>
  <PresentationFormat>Grand écran</PresentationFormat>
  <Paragraphs>20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nhattan</dc:creator>
  <cp:lastModifiedBy>Manhattan</cp:lastModifiedBy>
  <cp:revision>36</cp:revision>
  <dcterms:created xsi:type="dcterms:W3CDTF">2021-03-19T20:10:52Z</dcterms:created>
  <dcterms:modified xsi:type="dcterms:W3CDTF">2021-05-11T20:49:52Z</dcterms:modified>
</cp:coreProperties>
</file>